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6" r:id="rId2"/>
    <p:sldId id="271" r:id="rId3"/>
    <p:sldId id="26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81"/>
  </p:normalViewPr>
  <p:slideViewPr>
    <p:cSldViewPr snapToGrid="0">
      <p:cViewPr varScale="1">
        <p:scale>
          <a:sx n="111" d="100"/>
          <a:sy n="111" d="100"/>
        </p:scale>
        <p:origin x="440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4AE82B-5131-3F9F-C4A3-E30B4927D8D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165D3F4-6821-E34A-CC01-F53DD6330A9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E97380-9916-4BD2-7708-BD280E6457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F23642-78B7-9F4B-B574-BB1890D44435}" type="datetimeFigureOut">
              <a:rPr lang="en-US" smtClean="0"/>
              <a:t>3/26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CA8E85-5200-DB06-7C47-28C554183B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FA9DF3-D369-E8B4-90F2-8391332797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2C4DFA-B101-B941-BB7C-11D7C25241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23818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617186-BF62-220A-7552-4BB8773086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4E486F1-8B8F-0F1D-78F0-C9B5D662C61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F560FB-0C84-0DCF-F59C-168DF1809C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F23642-78B7-9F4B-B574-BB1890D44435}" type="datetimeFigureOut">
              <a:rPr lang="en-US" smtClean="0"/>
              <a:t>3/26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DCE433-C039-FAFC-3F85-019CDBE0FA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7BA4A7-897B-5A49-71C4-97D7236432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2C4DFA-B101-B941-BB7C-11D7C25241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24357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7C028BD-09D0-0378-20E6-6D1F7C47A98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6CF5CC8-84BD-79F3-7715-A3F7142416D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9411B2-E933-D949-82E8-B05DC50D8C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F23642-78B7-9F4B-B574-BB1890D44435}" type="datetimeFigureOut">
              <a:rPr lang="en-US" smtClean="0"/>
              <a:t>3/26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A0D564-260F-54C1-D0F0-FD8D04BC01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0389AD-E156-0A19-6EF0-A12B4156C5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2C4DFA-B101-B941-BB7C-11D7C25241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08955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C5FB2B-40DD-CB9D-F7DB-6EA9F32B4F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4AF406D-57EE-1281-447A-C5143649DC2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2AFE7C-3F17-3402-B98B-FD501D4A3A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F23642-78B7-9F4B-B574-BB1890D44435}" type="datetimeFigureOut">
              <a:rPr lang="en-US" smtClean="0"/>
              <a:t>3/26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D2A9B0-A657-C43F-ED45-FFA71F4EF7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B9D9B1D-015B-FA07-E51C-A6EB4C7E52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2C4DFA-B101-B941-BB7C-11D7C25241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4404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068493-A1D5-9E36-C6A1-9646D3BE94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0F5D85D-2EA0-008E-5C82-4704D5D9BD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031DE3-2421-148F-3057-332F130157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F23642-78B7-9F4B-B574-BB1890D44435}" type="datetimeFigureOut">
              <a:rPr lang="en-US" smtClean="0"/>
              <a:t>3/26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22446E-5007-C017-0FCA-B5DC195F0B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3AA816-CA69-35BD-1EFB-3A43DA9D8C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2C4DFA-B101-B941-BB7C-11D7C25241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6771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BC609E-CC31-5550-09CC-DA4D4ED61A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91F237B-0C77-F71F-EEE0-C19BE185345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80314C8-A7D7-628C-5EFF-7188630E036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1129A26-E97F-7777-AC80-14B5C3599B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F23642-78B7-9F4B-B574-BB1890D44435}" type="datetimeFigureOut">
              <a:rPr lang="en-US" smtClean="0"/>
              <a:t>3/26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86FBA37-71A4-C723-8CC1-ABFB6258D7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5C09B8C-110A-0712-D193-5A7B42F236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2C4DFA-B101-B941-BB7C-11D7C25241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29106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E07E2D-458C-C1CC-36F2-249CB5D96A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0E80B59-C5A5-D4A3-4EF9-AF8F0EA8E4B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06590B8-3F84-3315-E1DD-4507F79858C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A3BF407-4522-1DC6-0A44-0A9E03616FF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47B90CF-30EE-9302-A11F-F39D1819FBB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CDABF9B-4A70-96A6-AD5A-67A7AE2E4D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F23642-78B7-9F4B-B574-BB1890D44435}" type="datetimeFigureOut">
              <a:rPr lang="en-US" smtClean="0"/>
              <a:t>3/26/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A4BAAFD-3D90-5E67-99D3-4B06B686B7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FBBA513-EC93-98E3-683A-5DB78CC2ED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2C4DFA-B101-B941-BB7C-11D7C25241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26934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3EBD96-E88E-393D-18E4-3DD685EE1F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027A282-29A0-4FA1-4264-77B9AE6123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F23642-78B7-9F4B-B574-BB1890D44435}" type="datetimeFigureOut">
              <a:rPr lang="en-US" smtClean="0"/>
              <a:t>3/26/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AA390F3-D243-F8E3-E216-C45E2CA58D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70F3B93-B306-6D3C-715D-DF4744274D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2C4DFA-B101-B941-BB7C-11D7C25241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48640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14C5BEB-230B-1F35-C18C-4B1982C61B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F23642-78B7-9F4B-B574-BB1890D44435}" type="datetimeFigureOut">
              <a:rPr lang="en-US" smtClean="0"/>
              <a:t>3/26/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D454E06-3D3B-A969-0524-68D39A63FC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3E519D2-5540-8342-454E-C866953B77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2C4DFA-B101-B941-BB7C-11D7C25241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27298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6EEDB8-6FCC-4C07-997F-1293F5AB4A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D9908B8-A9C4-8FD7-AD16-53D8D2266FA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17E8957-AF27-E9FE-AA98-88467ACF742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01DBBE9-F44D-ABCB-2EA7-893D15C066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F23642-78B7-9F4B-B574-BB1890D44435}" type="datetimeFigureOut">
              <a:rPr lang="en-US" smtClean="0"/>
              <a:t>3/26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7734F32-34EE-3EB5-A9BB-54A7D6224D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37C7036-3B81-51D1-3A07-4C48CDE8A1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2C4DFA-B101-B941-BB7C-11D7C25241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50013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89701D-EEAA-5E3C-D8CC-0D36D88559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C8EFB86-638B-91D5-3B79-FD1CAE8C231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AB425DC-4E6D-7C4D-E7EC-F22B22654CC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EF563D3-82A8-5F4E-7C1B-04CEF4E476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F23642-78B7-9F4B-B574-BB1890D44435}" type="datetimeFigureOut">
              <a:rPr lang="en-US" smtClean="0"/>
              <a:t>3/26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31AF5E5-99CE-3D58-6366-54CC12772D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33F7BF1-AE95-C02A-7C11-A40949D486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2C4DFA-B101-B941-BB7C-11D7C25241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98233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EAE1205-7B29-87B0-FEF3-4E2F9D9A26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CCB2741-8E9F-DC6E-F775-5291BF1FE05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88DFCD3-F53C-B519-9B4F-E206131D0AA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0F23642-78B7-9F4B-B574-BB1890D44435}" type="datetimeFigureOut">
              <a:rPr lang="en-US" smtClean="0"/>
              <a:t>3/26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3996DE-261E-0F4A-534E-4E37387D9F0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536908-6B55-DB94-9BEF-D2ED229349C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E2C4DFA-B101-B941-BB7C-11D7C25241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49240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7" Type="http://schemas.openxmlformats.org/officeDocument/2006/relationships/image" Target="../media/image5.emf"/><Relationship Id="rId2" Type="http://schemas.openxmlformats.org/officeDocument/2006/relationships/oleObject" Target="../embeddings/oleObject3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5.bin"/><Relationship Id="rId5" Type="http://schemas.openxmlformats.org/officeDocument/2006/relationships/image" Target="../media/image4.emf"/><Relationship Id="rId4" Type="http://schemas.openxmlformats.org/officeDocument/2006/relationships/oleObject" Target="../embeddings/oleObject4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7" Type="http://schemas.openxmlformats.org/officeDocument/2006/relationships/image" Target="../media/image8.emf"/><Relationship Id="rId2" Type="http://schemas.openxmlformats.org/officeDocument/2006/relationships/oleObject" Target="../embeddings/oleObject6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8.bin"/><Relationship Id="rId5" Type="http://schemas.openxmlformats.org/officeDocument/2006/relationships/image" Target="../media/image7.emf"/><Relationship Id="rId4" Type="http://schemas.openxmlformats.org/officeDocument/2006/relationships/oleObject" Target="../embeddings/oleObject7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id="{6FC877DA-006E-D71E-B556-29E00D9B6AB3}"/>
              </a:ext>
            </a:extLst>
          </p:cNvPr>
          <p:cNvGrpSpPr/>
          <p:nvPr/>
        </p:nvGrpSpPr>
        <p:grpSpPr>
          <a:xfrm>
            <a:off x="273114" y="541528"/>
            <a:ext cx="3832225" cy="5957887"/>
            <a:chOff x="1427544" y="541528"/>
            <a:chExt cx="3832225" cy="5957887"/>
          </a:xfrm>
        </p:grpSpPr>
        <p:graphicFrame>
          <p:nvGraphicFramePr>
            <p:cNvPr id="3" name="Object 2">
              <a:extLst>
                <a:ext uri="{FF2B5EF4-FFF2-40B4-BE49-F238E27FC236}">
                  <a16:creationId xmlns:a16="http://schemas.microsoft.com/office/drawing/2014/main" id="{31DB872C-F89F-EBA1-30A3-9D62AAD58ACB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1427544" y="541528"/>
            <a:ext cx="3832225" cy="59578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2" imgW="3832924" imgH="5958388" progId="Prism10.Document">
                    <p:embed/>
                  </p:oleObj>
                </mc:Choice>
                <mc:Fallback>
                  <p:oleObj name="Prism 10" r:id="rId2" imgW="3832924" imgH="5958388" progId="Prism10.Document">
                    <p:embed/>
                    <p:pic>
                      <p:nvPicPr>
                        <p:cNvPr id="3" name="Object 2">
                          <a:extLst>
                            <a:ext uri="{FF2B5EF4-FFF2-40B4-BE49-F238E27FC236}">
                              <a16:creationId xmlns:a16="http://schemas.microsoft.com/office/drawing/2014/main" id="{31DB872C-F89F-EBA1-30A3-9D62AAD58AC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1427544" y="541528"/>
                          <a:ext cx="3832225" cy="59578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EAE1FB1F-8A29-5F51-F302-14DF05778C99}"/>
                </a:ext>
              </a:extLst>
            </p:cNvPr>
            <p:cNvSpPr txBox="1"/>
            <p:nvPr/>
          </p:nvSpPr>
          <p:spPr>
            <a:xfrm>
              <a:off x="1938528" y="541528"/>
              <a:ext cx="85953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A</a:t>
              </a:r>
            </a:p>
          </p:txBody>
        </p: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2D71C589-9A3C-5E16-4535-BC78803BA90C}"/>
              </a:ext>
            </a:extLst>
          </p:cNvPr>
          <p:cNvGrpSpPr/>
          <p:nvPr/>
        </p:nvGrpSpPr>
        <p:grpSpPr>
          <a:xfrm>
            <a:off x="3956939" y="541528"/>
            <a:ext cx="3471863" cy="5535613"/>
            <a:chOff x="7111619" y="541528"/>
            <a:chExt cx="3471863" cy="5535613"/>
          </a:xfrm>
        </p:grpSpPr>
        <p:graphicFrame>
          <p:nvGraphicFramePr>
            <p:cNvPr id="2" name="Object 1">
              <a:extLst>
                <a:ext uri="{FF2B5EF4-FFF2-40B4-BE49-F238E27FC236}">
                  <a16:creationId xmlns:a16="http://schemas.microsoft.com/office/drawing/2014/main" id="{6BB77BDB-5ED1-B1D9-AEC9-2437FDB1211E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7111619" y="541528"/>
            <a:ext cx="3471863" cy="55356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4" imgW="3471348" imgH="5535928" progId="Prism10.Document">
                    <p:embed/>
                  </p:oleObj>
                </mc:Choice>
                <mc:Fallback>
                  <p:oleObj name="Prism 10" r:id="rId4" imgW="3471348" imgH="5535928" progId="Prism10.Document">
                    <p:embed/>
                    <p:pic>
                      <p:nvPicPr>
                        <p:cNvPr id="2" name="Object 1">
                          <a:extLst>
                            <a:ext uri="{FF2B5EF4-FFF2-40B4-BE49-F238E27FC236}">
                              <a16:creationId xmlns:a16="http://schemas.microsoft.com/office/drawing/2014/main" id="{6BB77BDB-5ED1-B1D9-AEC9-2437FDB1211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7111619" y="541528"/>
                          <a:ext cx="3471863" cy="553561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182D5D78-B68C-CFEC-12A2-B1804989E37B}"/>
                </a:ext>
              </a:extLst>
            </p:cNvPr>
            <p:cNvSpPr txBox="1"/>
            <p:nvPr/>
          </p:nvSpPr>
          <p:spPr>
            <a:xfrm>
              <a:off x="7507224" y="541528"/>
              <a:ext cx="64922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B</a:t>
              </a:r>
            </a:p>
          </p:txBody>
        </p:sp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E9864C46-2408-E434-1571-196CAE6C847D}"/>
              </a:ext>
            </a:extLst>
          </p:cNvPr>
          <p:cNvSpPr txBox="1"/>
          <p:nvPr/>
        </p:nvSpPr>
        <p:spPr>
          <a:xfrm>
            <a:off x="155448" y="109728"/>
            <a:ext cx="32369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</a:t>
            </a:r>
            <a:r>
              <a:rPr lang="en-US"/>
              <a:t>Figure S1</a:t>
            </a:r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59661A2-159D-8256-49FE-015831C164BC}"/>
              </a:ext>
            </a:extLst>
          </p:cNvPr>
          <p:cNvSpPr txBox="1"/>
          <p:nvPr/>
        </p:nvSpPr>
        <p:spPr>
          <a:xfrm>
            <a:off x="7428802" y="1037979"/>
            <a:ext cx="4490084" cy="286232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Supplemental </a:t>
            </a:r>
            <a:r>
              <a:rPr lang="en-US" sz="180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Figure S1</a:t>
            </a:r>
            <a:r>
              <a:rPr lang="en-US" sz="1800" dirty="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. </a:t>
            </a:r>
          </a:p>
          <a:p>
            <a:r>
              <a:rPr lang="en-US" sz="1800" dirty="0" err="1">
                <a:effectLst/>
                <a:latin typeface="Arial" panose="020B0604020202020204" pitchFamily="34" charset="0"/>
                <a:ea typeface="Aptos" panose="020B0004020202020204" pitchFamily="34" charset="0"/>
              </a:rPr>
              <a:t>AoD</a:t>
            </a:r>
            <a:r>
              <a:rPr lang="en-US" sz="1800" dirty="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 of</a:t>
            </a:r>
            <a:r>
              <a:rPr lang="en-US" sz="1800" b="1" dirty="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 </a:t>
            </a:r>
            <a:r>
              <a:rPr lang="en-US" sz="1800" dirty="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(A) MyH11</a:t>
            </a:r>
            <a:r>
              <a:rPr lang="en-US" sz="1800" baseline="30000" dirty="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Cre-EGFP</a:t>
            </a:r>
            <a:r>
              <a:rPr lang="en-US" sz="1800" dirty="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 and (B) SGK-1</a:t>
            </a:r>
            <a:r>
              <a:rPr lang="en-US" sz="1800" baseline="30000" dirty="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flox/</a:t>
            </a:r>
            <a:r>
              <a:rPr lang="en-US" sz="1800" baseline="30000" dirty="0" err="1">
                <a:effectLst/>
                <a:latin typeface="Arial" panose="020B0604020202020204" pitchFamily="34" charset="0"/>
                <a:ea typeface="Aptos" panose="020B0004020202020204" pitchFamily="34" charset="0"/>
              </a:rPr>
              <a:t>flox</a:t>
            </a:r>
            <a:r>
              <a:rPr lang="en-US" sz="1800" dirty="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 mice +/- AAA induction and +/- EMD treatment at day 21. Solid black line represents average baseline aortic diameter at day 0. Dotted black line represents an average 50% increase in diameter to represent the threshold of a true AAA. Statistical analysis represents ANOVA.</a:t>
            </a:r>
            <a:r>
              <a:rPr lang="en-US" dirty="0">
                <a:effectLst/>
              </a:rPr>
              <a:t>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314276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60A3C57A-3CFB-BFD2-6DB8-17B63E44BD1B}"/>
              </a:ext>
            </a:extLst>
          </p:cNvPr>
          <p:cNvSpPr txBox="1"/>
          <p:nvPr/>
        </p:nvSpPr>
        <p:spPr>
          <a:xfrm>
            <a:off x="347472" y="246888"/>
            <a:ext cx="30083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</a:t>
            </a:r>
            <a:r>
              <a:rPr lang="en-US"/>
              <a:t>Figure S2</a:t>
            </a:r>
            <a:endParaRPr lang="en-US" dirty="0"/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509231AA-BE97-F5FC-C532-B6A49EDB6D0A}"/>
              </a:ext>
            </a:extLst>
          </p:cNvPr>
          <p:cNvGrpSpPr/>
          <p:nvPr/>
        </p:nvGrpSpPr>
        <p:grpSpPr>
          <a:xfrm>
            <a:off x="671449" y="469122"/>
            <a:ext cx="3371269" cy="4958985"/>
            <a:chOff x="671449" y="880602"/>
            <a:chExt cx="3371269" cy="4958985"/>
          </a:xfrm>
        </p:grpSpPr>
        <p:graphicFrame>
          <p:nvGraphicFramePr>
            <p:cNvPr id="2" name="Object 1">
              <a:extLst>
                <a:ext uri="{FF2B5EF4-FFF2-40B4-BE49-F238E27FC236}">
                  <a16:creationId xmlns:a16="http://schemas.microsoft.com/office/drawing/2014/main" id="{F79736E1-948E-A382-A3F3-DE6A433F846B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671449" y="1018413"/>
            <a:ext cx="3371269" cy="482117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2" imgW="3916476" imgH="5601476" progId="Prism10.Document">
                    <p:embed/>
                  </p:oleObj>
                </mc:Choice>
                <mc:Fallback>
                  <p:oleObj name="Prism 10" r:id="rId2" imgW="3916476" imgH="5601476" progId="Prism10.Document">
                    <p:embed/>
                    <p:pic>
                      <p:nvPicPr>
                        <p:cNvPr id="2" name="Object 1">
                          <a:extLst>
                            <a:ext uri="{FF2B5EF4-FFF2-40B4-BE49-F238E27FC236}">
                              <a16:creationId xmlns:a16="http://schemas.microsoft.com/office/drawing/2014/main" id="{F79736E1-948E-A382-A3F3-DE6A433F846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671449" y="1018413"/>
                          <a:ext cx="3371269" cy="482117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FDFB1A1C-8822-9585-2504-351A202F537A}"/>
                </a:ext>
              </a:extLst>
            </p:cNvPr>
            <p:cNvSpPr txBox="1"/>
            <p:nvPr/>
          </p:nvSpPr>
          <p:spPr>
            <a:xfrm>
              <a:off x="1225748" y="880602"/>
              <a:ext cx="42062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A</a:t>
              </a:r>
            </a:p>
          </p:txBody>
        </p:sp>
      </p:grpSp>
      <p:grpSp>
        <p:nvGrpSpPr>
          <p:cNvPr id="9" name="Group 8">
            <a:extLst>
              <a:ext uri="{FF2B5EF4-FFF2-40B4-BE49-F238E27FC236}">
                <a16:creationId xmlns:a16="http://schemas.microsoft.com/office/drawing/2014/main" id="{92EC5621-4091-2E56-174E-91336D608AC7}"/>
              </a:ext>
            </a:extLst>
          </p:cNvPr>
          <p:cNvGrpSpPr/>
          <p:nvPr/>
        </p:nvGrpSpPr>
        <p:grpSpPr>
          <a:xfrm>
            <a:off x="4408930" y="465693"/>
            <a:ext cx="3374139" cy="5172218"/>
            <a:chOff x="4408930" y="877173"/>
            <a:chExt cx="3374139" cy="5172218"/>
          </a:xfrm>
        </p:grpSpPr>
        <p:graphicFrame>
          <p:nvGraphicFramePr>
            <p:cNvPr id="4" name="Object 3">
              <a:extLst>
                <a:ext uri="{FF2B5EF4-FFF2-40B4-BE49-F238E27FC236}">
                  <a16:creationId xmlns:a16="http://schemas.microsoft.com/office/drawing/2014/main" id="{AF73E652-9AE9-9F8F-951B-9BBE0DFABF90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4408930" y="1228217"/>
            <a:ext cx="3374139" cy="482117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4" imgW="3916476" imgH="5595353" progId="Prism10.Document">
                    <p:embed/>
                  </p:oleObj>
                </mc:Choice>
                <mc:Fallback>
                  <p:oleObj name="Prism 10" r:id="rId4" imgW="3916476" imgH="5595353" progId="Prism10.Document">
                    <p:embed/>
                    <p:pic>
                      <p:nvPicPr>
                        <p:cNvPr id="4" name="Object 3">
                          <a:extLst>
                            <a:ext uri="{FF2B5EF4-FFF2-40B4-BE49-F238E27FC236}">
                              <a16:creationId xmlns:a16="http://schemas.microsoft.com/office/drawing/2014/main" id="{AF73E652-9AE9-9F8F-951B-9BBE0DFABF9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4408930" y="1228217"/>
                          <a:ext cx="3374139" cy="482117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CB2B495E-D2AB-8904-F82C-A972679872FB}"/>
                </a:ext>
              </a:extLst>
            </p:cNvPr>
            <p:cNvSpPr txBox="1"/>
            <p:nvPr/>
          </p:nvSpPr>
          <p:spPr>
            <a:xfrm>
              <a:off x="5018977" y="877173"/>
              <a:ext cx="59436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B</a:t>
              </a:r>
            </a:p>
          </p:txBody>
        </p:sp>
      </p:grpSp>
      <p:grpSp>
        <p:nvGrpSpPr>
          <p:cNvPr id="11" name="Group 10">
            <a:extLst>
              <a:ext uri="{FF2B5EF4-FFF2-40B4-BE49-F238E27FC236}">
                <a16:creationId xmlns:a16="http://schemas.microsoft.com/office/drawing/2014/main" id="{72A6BCC1-EBAB-10AE-7A9A-F02A13C45B6F}"/>
              </a:ext>
            </a:extLst>
          </p:cNvPr>
          <p:cNvGrpSpPr/>
          <p:nvPr/>
        </p:nvGrpSpPr>
        <p:grpSpPr>
          <a:xfrm>
            <a:off x="7963790" y="465693"/>
            <a:ext cx="3367354" cy="5258451"/>
            <a:chOff x="7963790" y="877173"/>
            <a:chExt cx="3367354" cy="5258451"/>
          </a:xfrm>
        </p:grpSpPr>
        <p:graphicFrame>
          <p:nvGraphicFramePr>
            <p:cNvPr id="3" name="Object 2">
              <a:extLst>
                <a:ext uri="{FF2B5EF4-FFF2-40B4-BE49-F238E27FC236}">
                  <a16:creationId xmlns:a16="http://schemas.microsoft.com/office/drawing/2014/main" id="{D8C8EBEB-B2D7-24F4-3E92-07BD07BC92D4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7963790" y="1141984"/>
            <a:ext cx="3367354" cy="499364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6" imgW="4145162" imgH="6146029" progId="Prism10.Document">
                    <p:embed/>
                  </p:oleObj>
                </mc:Choice>
                <mc:Fallback>
                  <p:oleObj name="Prism 10" r:id="rId6" imgW="4145162" imgH="6146029" progId="Prism10.Document">
                    <p:embed/>
                    <p:pic>
                      <p:nvPicPr>
                        <p:cNvPr id="3" name="Object 2">
                          <a:extLst>
                            <a:ext uri="{FF2B5EF4-FFF2-40B4-BE49-F238E27FC236}">
                              <a16:creationId xmlns:a16="http://schemas.microsoft.com/office/drawing/2014/main" id="{D8C8EBEB-B2D7-24F4-3E92-07BD07BC92D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7963790" y="1141984"/>
                          <a:ext cx="3367354" cy="499364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D37CB6CB-D332-2CED-588D-A5257FB6A8F8}"/>
                </a:ext>
              </a:extLst>
            </p:cNvPr>
            <p:cNvSpPr txBox="1"/>
            <p:nvPr/>
          </p:nvSpPr>
          <p:spPr>
            <a:xfrm>
              <a:off x="8807634" y="877173"/>
              <a:ext cx="35661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C</a:t>
              </a:r>
            </a:p>
          </p:txBody>
        </p:sp>
      </p:grpSp>
      <p:sp>
        <p:nvSpPr>
          <p:cNvPr id="13" name="Rectangle 12">
            <a:extLst>
              <a:ext uri="{FF2B5EF4-FFF2-40B4-BE49-F238E27FC236}">
                <a16:creationId xmlns:a16="http://schemas.microsoft.com/office/drawing/2014/main" id="{BE5E21EE-C62D-B131-DA77-39C4E6596296}"/>
              </a:ext>
            </a:extLst>
          </p:cNvPr>
          <p:cNvSpPr/>
          <p:nvPr/>
        </p:nvSpPr>
        <p:spPr>
          <a:xfrm>
            <a:off x="1565910" y="730504"/>
            <a:ext cx="2171700" cy="24576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ln w="0"/>
                <a:solidFill>
                  <a:schemeClr val="tx1"/>
                </a:solidFill>
              </a:rPr>
              <a:t>Radial Strain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392A8F67-A0D3-ACBE-F49A-AA7ECEC936D6}"/>
              </a:ext>
            </a:extLst>
          </p:cNvPr>
          <p:cNvSpPr/>
          <p:nvPr/>
        </p:nvSpPr>
        <p:spPr>
          <a:xfrm>
            <a:off x="5303391" y="895025"/>
            <a:ext cx="2171700" cy="24576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ln w="0"/>
                <a:solidFill>
                  <a:schemeClr val="tx1"/>
                </a:solidFill>
              </a:rPr>
              <a:t>Distensibility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B67B2FF9-6FF2-84D1-1DFA-6BE92AB9B36E}"/>
              </a:ext>
            </a:extLst>
          </p:cNvPr>
          <p:cNvSpPr/>
          <p:nvPr/>
        </p:nvSpPr>
        <p:spPr>
          <a:xfrm>
            <a:off x="8858251" y="816737"/>
            <a:ext cx="2171700" cy="24576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ln w="0"/>
                <a:solidFill>
                  <a:schemeClr val="tx1"/>
                </a:solidFill>
              </a:rPr>
              <a:t>PPV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0D0B3CD-C56F-3C4A-0C8B-37AECCF04892}"/>
              </a:ext>
            </a:extLst>
          </p:cNvPr>
          <p:cNvSpPr txBox="1"/>
          <p:nvPr/>
        </p:nvSpPr>
        <p:spPr>
          <a:xfrm>
            <a:off x="347471" y="5624903"/>
            <a:ext cx="10682479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Aft>
                <a:spcPts val="800"/>
              </a:spcAft>
              <a:buNone/>
            </a:pPr>
            <a:r>
              <a:rPr lang="en-US" sz="18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upplemental </a:t>
            </a:r>
            <a:r>
              <a:rPr lang="en-US" sz="1800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Figure S2</a:t>
            </a:r>
            <a:r>
              <a:rPr lang="en-US" sz="18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. Ultrasound-derived mechanical parameters for MyH11</a:t>
            </a:r>
            <a:r>
              <a:rPr lang="en-US" sz="1800" kern="100" baseline="300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Cre-EGFP</a:t>
            </a:r>
            <a:r>
              <a:rPr lang="en-US" sz="18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mice +/- AAA induction at day 0 versus day 21 represented as (A) Radial strain, (B) Distensibility, and (C) PPV. Statistical analysis represents Student’s T-test. </a:t>
            </a:r>
            <a:r>
              <a:rPr lang="en-US" sz="18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endParaRPr lang="en-US" sz="20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1743096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8D64A541-B03F-F409-CA0E-BDADAFEC866E}"/>
              </a:ext>
            </a:extLst>
          </p:cNvPr>
          <p:cNvSpPr txBox="1"/>
          <p:nvPr/>
        </p:nvSpPr>
        <p:spPr>
          <a:xfrm>
            <a:off x="265176" y="210312"/>
            <a:ext cx="2971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</a:t>
            </a:r>
            <a:r>
              <a:rPr lang="en-US"/>
              <a:t>Figure S3</a:t>
            </a:r>
            <a:endParaRPr lang="en-US" dirty="0"/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247DCFDD-BFE0-E8DA-1E5D-FBD3386E637A}"/>
              </a:ext>
            </a:extLst>
          </p:cNvPr>
          <p:cNvGrpSpPr/>
          <p:nvPr/>
        </p:nvGrpSpPr>
        <p:grpSpPr>
          <a:xfrm>
            <a:off x="545211" y="418338"/>
            <a:ext cx="3161294" cy="4919472"/>
            <a:chOff x="545211" y="978408"/>
            <a:chExt cx="3161294" cy="4919472"/>
          </a:xfrm>
        </p:grpSpPr>
        <p:graphicFrame>
          <p:nvGraphicFramePr>
            <p:cNvPr id="2" name="Object 1">
              <a:extLst>
                <a:ext uri="{FF2B5EF4-FFF2-40B4-BE49-F238E27FC236}">
                  <a16:creationId xmlns:a16="http://schemas.microsoft.com/office/drawing/2014/main" id="{0409AB45-4CFB-B0C2-9BED-8797618CCDDB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545211" y="1241933"/>
            <a:ext cx="3161294" cy="465594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2" imgW="3677346" imgH="5415636" progId="Prism10.Document">
                    <p:embed/>
                  </p:oleObj>
                </mc:Choice>
                <mc:Fallback>
                  <p:oleObj name="Prism 10" r:id="rId2" imgW="3677346" imgH="5415636" progId="Prism10.Document">
                    <p:embed/>
                    <p:pic>
                      <p:nvPicPr>
                        <p:cNvPr id="2" name="Object 1">
                          <a:extLst>
                            <a:ext uri="{FF2B5EF4-FFF2-40B4-BE49-F238E27FC236}">
                              <a16:creationId xmlns:a16="http://schemas.microsoft.com/office/drawing/2014/main" id="{0409AB45-4CFB-B0C2-9BED-8797618CCDD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545211" y="1241933"/>
                          <a:ext cx="3161294" cy="465594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56D57680-A50B-AFC4-8BC2-92EAFE485FC9}"/>
                </a:ext>
              </a:extLst>
            </p:cNvPr>
            <p:cNvSpPr txBox="1"/>
            <p:nvPr/>
          </p:nvSpPr>
          <p:spPr>
            <a:xfrm>
              <a:off x="1194557" y="978408"/>
              <a:ext cx="5669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A</a:t>
              </a:r>
            </a:p>
          </p:txBody>
        </p:sp>
      </p:grpSp>
      <p:grpSp>
        <p:nvGrpSpPr>
          <p:cNvPr id="9" name="Group 8">
            <a:extLst>
              <a:ext uri="{FF2B5EF4-FFF2-40B4-BE49-F238E27FC236}">
                <a16:creationId xmlns:a16="http://schemas.microsoft.com/office/drawing/2014/main" id="{59738A06-C0C5-8B07-B730-FC01872D442F}"/>
              </a:ext>
            </a:extLst>
          </p:cNvPr>
          <p:cNvGrpSpPr/>
          <p:nvPr/>
        </p:nvGrpSpPr>
        <p:grpSpPr>
          <a:xfrm>
            <a:off x="4431411" y="418338"/>
            <a:ext cx="3152054" cy="4919473"/>
            <a:chOff x="4431411" y="978408"/>
            <a:chExt cx="3152054" cy="4919473"/>
          </a:xfrm>
        </p:grpSpPr>
        <p:graphicFrame>
          <p:nvGraphicFramePr>
            <p:cNvPr id="3" name="Object 2">
              <a:extLst>
                <a:ext uri="{FF2B5EF4-FFF2-40B4-BE49-F238E27FC236}">
                  <a16:creationId xmlns:a16="http://schemas.microsoft.com/office/drawing/2014/main" id="{8FE5BCE2-BD05-B131-9B07-0D9AC03CA9DD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4431411" y="1241933"/>
            <a:ext cx="3152054" cy="465594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4" imgW="3677346" imgH="5430763" progId="Prism10.Document">
                    <p:embed/>
                  </p:oleObj>
                </mc:Choice>
                <mc:Fallback>
                  <p:oleObj name="Prism 10" r:id="rId4" imgW="3677346" imgH="5430763" progId="Prism10.Document">
                    <p:embed/>
                    <p:pic>
                      <p:nvPicPr>
                        <p:cNvPr id="3" name="Object 2">
                          <a:extLst>
                            <a:ext uri="{FF2B5EF4-FFF2-40B4-BE49-F238E27FC236}">
                              <a16:creationId xmlns:a16="http://schemas.microsoft.com/office/drawing/2014/main" id="{8FE5BCE2-BD05-B131-9B07-0D9AC03CA9DD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4431411" y="1241933"/>
                          <a:ext cx="3152054" cy="465594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A99C4FC2-C184-FD0E-6BB2-C48BBD451B4E}"/>
                </a:ext>
              </a:extLst>
            </p:cNvPr>
            <p:cNvSpPr txBox="1"/>
            <p:nvPr/>
          </p:nvSpPr>
          <p:spPr>
            <a:xfrm>
              <a:off x="5043182" y="978408"/>
              <a:ext cx="5669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B</a:t>
              </a:r>
            </a:p>
          </p:txBody>
        </p:sp>
      </p:grpSp>
      <p:grpSp>
        <p:nvGrpSpPr>
          <p:cNvPr id="11" name="Group 10">
            <a:extLst>
              <a:ext uri="{FF2B5EF4-FFF2-40B4-BE49-F238E27FC236}">
                <a16:creationId xmlns:a16="http://schemas.microsoft.com/office/drawing/2014/main" id="{E40D8C80-DAC4-9F94-A9B5-BD6934808FA9}"/>
              </a:ext>
            </a:extLst>
          </p:cNvPr>
          <p:cNvGrpSpPr/>
          <p:nvPr/>
        </p:nvGrpSpPr>
        <p:grpSpPr>
          <a:xfrm>
            <a:off x="8217027" y="418338"/>
            <a:ext cx="3155744" cy="4919472"/>
            <a:chOff x="8217027" y="978408"/>
            <a:chExt cx="3155744" cy="4919472"/>
          </a:xfrm>
        </p:grpSpPr>
        <p:graphicFrame>
          <p:nvGraphicFramePr>
            <p:cNvPr id="4" name="Object 3">
              <a:extLst>
                <a:ext uri="{FF2B5EF4-FFF2-40B4-BE49-F238E27FC236}">
                  <a16:creationId xmlns:a16="http://schemas.microsoft.com/office/drawing/2014/main" id="{A870C5F0-8363-3BBF-033D-757D4326AC00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8217027" y="1241932"/>
            <a:ext cx="3155744" cy="465594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6" imgW="3677346" imgH="5424640" progId="Prism10.Document">
                    <p:embed/>
                  </p:oleObj>
                </mc:Choice>
                <mc:Fallback>
                  <p:oleObj name="Prism 10" r:id="rId6" imgW="3677346" imgH="5424640" progId="Prism10.Document">
                    <p:embed/>
                    <p:pic>
                      <p:nvPicPr>
                        <p:cNvPr id="4" name="Object 3">
                          <a:extLst>
                            <a:ext uri="{FF2B5EF4-FFF2-40B4-BE49-F238E27FC236}">
                              <a16:creationId xmlns:a16="http://schemas.microsoft.com/office/drawing/2014/main" id="{A870C5F0-8363-3BBF-033D-757D4326AC0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8217027" y="1241932"/>
                          <a:ext cx="3155744" cy="465594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C2884D32-1CED-9663-274C-1C01DE023E33}"/>
                </a:ext>
              </a:extLst>
            </p:cNvPr>
            <p:cNvSpPr txBox="1"/>
            <p:nvPr/>
          </p:nvSpPr>
          <p:spPr>
            <a:xfrm>
              <a:off x="8796528" y="978408"/>
              <a:ext cx="5669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C</a:t>
              </a:r>
            </a:p>
          </p:txBody>
        </p:sp>
      </p:grpSp>
      <p:sp>
        <p:nvSpPr>
          <p:cNvPr id="13" name="Rectangle 12">
            <a:extLst>
              <a:ext uri="{FF2B5EF4-FFF2-40B4-BE49-F238E27FC236}">
                <a16:creationId xmlns:a16="http://schemas.microsoft.com/office/drawing/2014/main" id="{F2B5510C-4BD4-2352-3A64-67B634C9BCAB}"/>
              </a:ext>
            </a:extLst>
          </p:cNvPr>
          <p:cNvSpPr/>
          <p:nvPr/>
        </p:nvSpPr>
        <p:spPr>
          <a:xfrm>
            <a:off x="1565910" y="753364"/>
            <a:ext cx="2171700" cy="24576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ln w="0"/>
                <a:solidFill>
                  <a:schemeClr val="tx1"/>
                </a:solidFill>
              </a:rPr>
              <a:t>Radial Strain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F8A181C7-3310-C265-2E05-A68B37602431}"/>
              </a:ext>
            </a:extLst>
          </p:cNvPr>
          <p:cNvSpPr/>
          <p:nvPr/>
        </p:nvSpPr>
        <p:spPr>
          <a:xfrm>
            <a:off x="5303391" y="826445"/>
            <a:ext cx="2171700" cy="24576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ln w="0"/>
                <a:solidFill>
                  <a:schemeClr val="tx1"/>
                </a:solidFill>
              </a:rPr>
              <a:t>Distensibility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C324A8E0-B454-5BCF-20DF-4D72C997501F}"/>
              </a:ext>
            </a:extLst>
          </p:cNvPr>
          <p:cNvSpPr/>
          <p:nvPr/>
        </p:nvSpPr>
        <p:spPr>
          <a:xfrm>
            <a:off x="8858251" y="782447"/>
            <a:ext cx="2171700" cy="24576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ln w="0"/>
                <a:solidFill>
                  <a:schemeClr val="tx1"/>
                </a:solidFill>
              </a:rPr>
              <a:t>PPV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223D5EA-84AC-0F87-BF94-1E36A3F83F1F}"/>
              </a:ext>
            </a:extLst>
          </p:cNvPr>
          <p:cNvSpPr txBox="1"/>
          <p:nvPr/>
        </p:nvSpPr>
        <p:spPr>
          <a:xfrm>
            <a:off x="602059" y="5651962"/>
            <a:ext cx="10344150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Aft>
                <a:spcPts val="800"/>
              </a:spcAft>
              <a:buNone/>
            </a:pPr>
            <a:r>
              <a:rPr lang="en-US" sz="18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upplemental </a:t>
            </a:r>
            <a:r>
              <a:rPr lang="en-US" sz="1800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Figure S3</a:t>
            </a:r>
            <a:r>
              <a:rPr lang="en-US" sz="18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. Ultrasound-derived mechanical parameters for SGK-1</a:t>
            </a:r>
            <a:r>
              <a:rPr lang="en-US" sz="1800" kern="100" baseline="300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flox/</a:t>
            </a:r>
            <a:r>
              <a:rPr lang="en-US" sz="1800" kern="100" baseline="300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flox</a:t>
            </a:r>
            <a:r>
              <a:rPr lang="en-US" sz="18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mice +/- AAA induction at day 0 versus day 21 represented as (A) Radial strain, (B) Distensibility, and (C) PPV. Statistical analysis represents Student’s T-test. </a:t>
            </a:r>
            <a:r>
              <a:rPr lang="en-US" sz="18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endParaRPr lang="en-US" sz="20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105070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181</Words>
  <Application>Microsoft Macintosh PowerPoint</Application>
  <PresentationFormat>Widescreen</PresentationFormat>
  <Paragraphs>21</Paragraphs>
  <Slides>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ptos</vt:lpstr>
      <vt:lpstr>Aptos Display</vt:lpstr>
      <vt:lpstr>Arial</vt:lpstr>
      <vt:lpstr>Office Theme</vt:lpstr>
      <vt:lpstr>Prism 10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jeanieruddy@gmail.com</dc:creator>
  <cp:lastModifiedBy>jeanieruddy@gmail.com</cp:lastModifiedBy>
  <cp:revision>3</cp:revision>
  <dcterms:created xsi:type="dcterms:W3CDTF">2025-12-24T15:48:30Z</dcterms:created>
  <dcterms:modified xsi:type="dcterms:W3CDTF">2026-03-26T13:20:38Z</dcterms:modified>
</cp:coreProperties>
</file>